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32" r:id="rId2"/>
  </p:sldIdLst>
  <p:sldSz cx="6858000" cy="9906000" type="A4"/>
  <p:notesSz cx="6792913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5FB"/>
    <a:srgbClr val="FFF2CC"/>
    <a:srgbClr val="FEF8D3"/>
    <a:srgbClr val="E1FDFA"/>
    <a:srgbClr val="CDFDD4"/>
    <a:srgbClr val="BDF4CA"/>
    <a:srgbClr val="73FDD6"/>
    <a:srgbClr val="EBEBEB"/>
    <a:srgbClr val="C23864"/>
    <a:srgbClr val="D538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Estilo medio 4 - Énfasis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33" autoAdjust="0"/>
    <p:restoredTop sz="96374" autoAdjust="0"/>
  </p:normalViewPr>
  <p:slideViewPr>
    <p:cSldViewPr snapToGrid="0">
      <p:cViewPr>
        <p:scale>
          <a:sx n="140" d="100"/>
          <a:sy n="140" d="100"/>
        </p:scale>
        <p:origin x="2196" y="6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596" cy="49797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47745" y="0"/>
            <a:ext cx="2943596" cy="49797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33E1AD-8E9D-FF4D-BB48-5C070C02522E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39838"/>
            <a:ext cx="2319337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292" y="4776431"/>
            <a:ext cx="5434330" cy="3907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7076"/>
            <a:ext cx="2943596" cy="4979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47745" y="9427076"/>
            <a:ext cx="2943596" cy="4979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446894-536D-F641-9BDA-2B430038702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5529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5446894-536D-F641-9BDA-2B430038702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00843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1772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8253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4159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6147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2735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9890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7438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74548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52352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3163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7319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F465F-1E11-3A4E-91DE-397B0471FD67}" type="datetimeFigureOut">
              <a:rPr lang="es-ES" smtClean="0"/>
              <a:t>08/10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E5AFC-4CEE-4F4A-A615-F5C7A01E3AF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8000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>
            <a:extLst>
              <a:ext uri="{FF2B5EF4-FFF2-40B4-BE49-F238E27FC236}">
                <a16:creationId xmlns:a16="http://schemas.microsoft.com/office/drawing/2014/main" id="{15DD311D-3352-4841-B24E-87A5881700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4276380"/>
              </p:ext>
            </p:extLst>
          </p:nvPr>
        </p:nvGraphicFramePr>
        <p:xfrm>
          <a:off x="704850" y="987706"/>
          <a:ext cx="5448300" cy="181127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20723">
                  <a:extLst>
                    <a:ext uri="{9D8B030D-6E8A-4147-A177-3AD203B41FA5}">
                      <a16:colId xmlns:a16="http://schemas.microsoft.com/office/drawing/2014/main" val="1646779192"/>
                    </a:ext>
                  </a:extLst>
                </a:gridCol>
                <a:gridCol w="1532989">
                  <a:extLst>
                    <a:ext uri="{9D8B030D-6E8A-4147-A177-3AD203B41FA5}">
                      <a16:colId xmlns:a16="http://schemas.microsoft.com/office/drawing/2014/main" val="1709479928"/>
                    </a:ext>
                  </a:extLst>
                </a:gridCol>
                <a:gridCol w="1418729">
                  <a:extLst>
                    <a:ext uri="{9D8B030D-6E8A-4147-A177-3AD203B41FA5}">
                      <a16:colId xmlns:a16="http://schemas.microsoft.com/office/drawing/2014/main" val="1796854404"/>
                    </a:ext>
                  </a:extLst>
                </a:gridCol>
                <a:gridCol w="399910">
                  <a:extLst>
                    <a:ext uri="{9D8B030D-6E8A-4147-A177-3AD203B41FA5}">
                      <a16:colId xmlns:a16="http://schemas.microsoft.com/office/drawing/2014/main" val="3536666023"/>
                    </a:ext>
                  </a:extLst>
                </a:gridCol>
                <a:gridCol w="1075949">
                  <a:extLst>
                    <a:ext uri="{9D8B030D-6E8A-4147-A177-3AD203B41FA5}">
                      <a16:colId xmlns:a16="http://schemas.microsoft.com/office/drawing/2014/main" val="4038489798"/>
                    </a:ext>
                  </a:extLst>
                </a:gridCol>
              </a:tblGrid>
              <a:tr h="179705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ene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Forward (5´&gt;3´)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verse (5´&gt;3´)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ize</a:t>
                      </a:r>
                      <a:endParaRPr lang="es-ES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00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ccession</a:t>
                      </a:r>
                      <a:r>
                        <a:rPr lang="es-ES" sz="1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#</a:t>
                      </a:r>
                      <a:endParaRPr lang="es-ES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3783905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L1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β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AGTGTGGATCCCAAGCAAT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CGGATTCCATGGTGAAGTC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01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M_008361.4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783313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NF</a:t>
                      </a:r>
                      <a:r>
                        <a:rPr lang="el-GR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α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GATTATGGCTCAGGGTCCAA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AGAGGCAACCTGACCACT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9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_001278601.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7017416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L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CCATCCAGTTGCCTTCTT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GAATTGCCATTGCACAAC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9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_001314054.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578729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CL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TTCCACAACCACCTCAAGC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AGGCATCACAGTCCGAGTC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_011333.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556938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LRP3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CTAAGAAGGACCAGCCAGA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GCAAACCCATCCACTCTT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9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M_145827.4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729313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LR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CCTGGCTGGTTTACACGTC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TGCCAGAGACATTGCAGAA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_021297.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400379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HC II</a:t>
                      </a:r>
                      <a:endParaRPr lang="es-ES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CCTCAAGCGACTGTGTTCC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GTCTGCGACTGACTTGCTA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34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M_010378.3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40956302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10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SF1R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GAAGGTGGCTGTGAAGATG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GGCTCCCAAGAGGTTGACT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2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M_001037859.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9310973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APDH</a:t>
                      </a:r>
                      <a:endParaRPr lang="es-E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GAACGGGAAGCTCACTGG</a:t>
                      </a:r>
                      <a:endParaRPr lang="es-ES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CCACCACCCTGTTGCTGTA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07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8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M_008084.3</a:t>
                      </a:r>
                      <a:endParaRPr lang="es-ES" sz="8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6229511"/>
                  </a:ext>
                </a:extLst>
              </a:tr>
            </a:tbl>
          </a:graphicData>
        </a:graphic>
      </p:graphicFrame>
      <p:sp>
        <p:nvSpPr>
          <p:cNvPr id="7" name="Rectángulo 6">
            <a:extLst>
              <a:ext uri="{FF2B5EF4-FFF2-40B4-BE49-F238E27FC236}">
                <a16:creationId xmlns:a16="http://schemas.microsoft.com/office/drawing/2014/main" id="{45BEC4E5-2BE1-4B31-9E13-D9C4F7436DCB}"/>
              </a:ext>
            </a:extLst>
          </p:cNvPr>
          <p:cNvSpPr/>
          <p:nvPr/>
        </p:nvSpPr>
        <p:spPr>
          <a:xfrm>
            <a:off x="606942" y="683008"/>
            <a:ext cx="4505580" cy="2922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</a:rPr>
              <a:t>Table S1.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</a:rPr>
              <a:t> Sequence of the primers used for qPCR</a:t>
            </a:r>
            <a:endParaRPr lang="es-ES" sz="12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6335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03</TotalTime>
  <Words>93</Words>
  <Application>Microsoft Office PowerPoint</Application>
  <PresentationFormat>A4 (210 x 297 mm)</PresentationFormat>
  <Paragraphs>5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Leon Rodriguez</dc:creator>
  <cp:lastModifiedBy>Maria De Los Dolores Lopez Avalos</cp:lastModifiedBy>
  <cp:revision>212</cp:revision>
  <cp:lastPrinted>2023-12-18T12:42:39Z</cp:lastPrinted>
  <dcterms:created xsi:type="dcterms:W3CDTF">2023-03-31T16:15:11Z</dcterms:created>
  <dcterms:modified xsi:type="dcterms:W3CDTF">2024-10-08T09:59:45Z</dcterms:modified>
</cp:coreProperties>
</file>